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2192000" cy="104409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327FACD-D3D7-457D-80C2-E0AD7E1E0F88}" v="1" dt="2024-03-25T12:55:30.68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5" d="100"/>
          <a:sy n="55" d="100"/>
        </p:scale>
        <p:origin x="1670" y="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an, Hyeondae" userId="67432371-20d1-4115-886e-4ef881c3fd68" providerId="ADAL" clId="{9327FACD-D3D7-457D-80C2-E0AD7E1E0F88}"/>
    <pc:docChg chg="undo custSel modSld">
      <pc:chgData name="Han, Hyeondae" userId="67432371-20d1-4115-886e-4ef881c3fd68" providerId="ADAL" clId="{9327FACD-D3D7-457D-80C2-E0AD7E1E0F88}" dt="2024-03-25T12:56:18.134" v="15" actId="6549"/>
      <pc:docMkLst>
        <pc:docMk/>
      </pc:docMkLst>
      <pc:sldChg chg="addSp modSp mod">
        <pc:chgData name="Han, Hyeondae" userId="67432371-20d1-4115-886e-4ef881c3fd68" providerId="ADAL" clId="{9327FACD-D3D7-457D-80C2-E0AD7E1E0F88}" dt="2024-03-25T12:56:18.134" v="15" actId="6549"/>
        <pc:sldMkLst>
          <pc:docMk/>
          <pc:sldMk cId="944935923" sldId="256"/>
        </pc:sldMkLst>
        <pc:spChg chg="add mod">
          <ac:chgData name="Han, Hyeondae" userId="67432371-20d1-4115-886e-4ef881c3fd68" providerId="ADAL" clId="{9327FACD-D3D7-457D-80C2-E0AD7E1E0F88}" dt="2024-03-25T12:56:18.134" v="15" actId="6549"/>
          <ac:spMkLst>
            <pc:docMk/>
            <pc:sldMk cId="944935923" sldId="256"/>
            <ac:spMk id="3" creationId="{0FC55D7F-9270-D044-2418-D4340986A5DD}"/>
          </ac:spMkLst>
        </pc:spChg>
        <pc:grpChg chg="mod">
          <ac:chgData name="Han, Hyeondae" userId="67432371-20d1-4115-886e-4ef881c3fd68" providerId="ADAL" clId="{9327FACD-D3D7-457D-80C2-E0AD7E1E0F88}" dt="2024-03-25T12:55:34.238" v="0" actId="1076"/>
          <ac:grpSpMkLst>
            <pc:docMk/>
            <pc:sldMk cId="944935923" sldId="256"/>
            <ac:grpSpMk id="496" creationId="{1919708B-0C9F-E965-1609-8C58EA5222B0}"/>
          </ac:grpSpMkLst>
        </pc:gr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708746"/>
            <a:ext cx="10363200" cy="3635011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5483936"/>
            <a:ext cx="9144000" cy="2520821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8414C8-D05A-423E-AE80-8294EC432E8C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281B5-D4C8-48D3-9FEA-BCFA7E2C7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91564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8414C8-D05A-423E-AE80-8294EC432E8C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281B5-D4C8-48D3-9FEA-BCFA7E2C7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79192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555886"/>
            <a:ext cx="2628900" cy="884825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555886"/>
            <a:ext cx="7734300" cy="884825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8414C8-D05A-423E-AE80-8294EC432E8C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281B5-D4C8-48D3-9FEA-BCFA7E2C7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59027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8414C8-D05A-423E-AE80-8294EC432E8C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281B5-D4C8-48D3-9FEA-BCFA7E2C7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97800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602999"/>
            <a:ext cx="10515600" cy="4343160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987248"/>
            <a:ext cx="10515600" cy="2283965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8414C8-D05A-423E-AE80-8294EC432E8C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281B5-D4C8-48D3-9FEA-BCFA7E2C7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6550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779430"/>
            <a:ext cx="5181600" cy="6624711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779430"/>
            <a:ext cx="5181600" cy="6624711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8414C8-D05A-423E-AE80-8294EC432E8C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281B5-D4C8-48D3-9FEA-BCFA7E2C7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22926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55888"/>
            <a:ext cx="10515600" cy="2018108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559493"/>
            <a:ext cx="5157787" cy="1254368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813861"/>
            <a:ext cx="5157787" cy="5609615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559493"/>
            <a:ext cx="5183188" cy="1254368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813861"/>
            <a:ext cx="5183188" cy="5609615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8414C8-D05A-423E-AE80-8294EC432E8C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281B5-D4C8-48D3-9FEA-BCFA7E2C7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34948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8414C8-D05A-423E-AE80-8294EC432E8C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281B5-D4C8-48D3-9FEA-BCFA7E2C7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15961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8414C8-D05A-423E-AE80-8294EC432E8C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281B5-D4C8-48D3-9FEA-BCFA7E2C7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51843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96066"/>
            <a:ext cx="3932237" cy="2436231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503311"/>
            <a:ext cx="6172200" cy="7419869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132296"/>
            <a:ext cx="3932237" cy="580296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8414C8-D05A-423E-AE80-8294EC432E8C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281B5-D4C8-48D3-9FEA-BCFA7E2C7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44016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96066"/>
            <a:ext cx="3932237" cy="2436231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503311"/>
            <a:ext cx="6172200" cy="7419869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132296"/>
            <a:ext cx="3932237" cy="580296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8414C8-D05A-423E-AE80-8294EC432E8C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281B5-D4C8-48D3-9FEA-BCFA7E2C7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90327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555888"/>
            <a:ext cx="10515600" cy="201810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779430"/>
            <a:ext cx="10515600" cy="662471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9677251"/>
            <a:ext cx="2743200" cy="55588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8414C8-D05A-423E-AE80-8294EC432E8C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9677251"/>
            <a:ext cx="4114800" cy="55588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9677251"/>
            <a:ext cx="2743200" cy="55588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0281B5-D4C8-48D3-9FEA-BCFA7E2C7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31514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6" name="Group 94">
            <a:extLst>
              <a:ext uri="{FF2B5EF4-FFF2-40B4-BE49-F238E27FC236}">
                <a16:creationId xmlns:a16="http://schemas.microsoft.com/office/drawing/2014/main" id="{1919708B-0C9F-E965-1609-8C58EA5222B0}"/>
              </a:ext>
            </a:extLst>
          </p:cNvPr>
          <p:cNvGrpSpPr/>
          <p:nvPr/>
        </p:nvGrpSpPr>
        <p:grpSpPr>
          <a:xfrm>
            <a:off x="1358495" y="244999"/>
            <a:ext cx="9475011" cy="9376226"/>
            <a:chOff x="2083981" y="8259557"/>
            <a:chExt cx="12201097" cy="12073890"/>
          </a:xfrm>
        </p:grpSpPr>
        <p:grpSp>
          <p:nvGrpSpPr>
            <p:cNvPr id="497" name="Group 93">
              <a:extLst>
                <a:ext uri="{FF2B5EF4-FFF2-40B4-BE49-F238E27FC236}">
                  <a16:creationId xmlns:a16="http://schemas.microsoft.com/office/drawing/2014/main" id="{D6692C5F-00E4-1E90-F41F-EC79211EA74F}"/>
                </a:ext>
              </a:extLst>
            </p:cNvPr>
            <p:cNvGrpSpPr/>
            <p:nvPr/>
          </p:nvGrpSpPr>
          <p:grpSpPr>
            <a:xfrm>
              <a:off x="2292278" y="8259557"/>
              <a:ext cx="11992800" cy="12073890"/>
              <a:chOff x="0" y="1965960"/>
              <a:chExt cx="6142382" cy="6183914"/>
            </a:xfrm>
          </p:grpSpPr>
          <p:grpSp>
            <p:nvGrpSpPr>
              <p:cNvPr id="500" name="Group 92">
                <a:extLst>
                  <a:ext uri="{FF2B5EF4-FFF2-40B4-BE49-F238E27FC236}">
                    <a16:creationId xmlns:a16="http://schemas.microsoft.com/office/drawing/2014/main" id="{829CA9CD-72A3-7B0A-0ED3-A22C529DCFCA}"/>
                  </a:ext>
                </a:extLst>
              </p:cNvPr>
              <p:cNvGrpSpPr/>
              <p:nvPr/>
            </p:nvGrpSpPr>
            <p:grpSpPr>
              <a:xfrm>
                <a:off x="0" y="1965960"/>
                <a:ext cx="6125029" cy="3063240"/>
                <a:chOff x="0" y="1965960"/>
                <a:chExt cx="6125029" cy="3063240"/>
              </a:xfrm>
            </p:grpSpPr>
            <p:pic>
              <p:nvPicPr>
                <p:cNvPr id="541" name="그림 5">
                  <a:extLst>
                    <a:ext uri="{FF2B5EF4-FFF2-40B4-BE49-F238E27FC236}">
                      <a16:creationId xmlns:a16="http://schemas.microsoft.com/office/drawing/2014/main" id="{DBC80E8A-8203-2CAA-FB2E-D5D64D31484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49762"/>
                <a:stretch/>
              </p:blipFill>
              <p:spPr>
                <a:xfrm>
                  <a:off x="0" y="1965960"/>
                  <a:ext cx="6125029" cy="2926080"/>
                </a:xfrm>
                <a:prstGeom prst="rect">
                  <a:avLst/>
                </a:prstGeom>
              </p:spPr>
            </p:pic>
            <p:grpSp>
              <p:nvGrpSpPr>
                <p:cNvPr id="542" name="그룹 14">
                  <a:extLst>
                    <a:ext uri="{FF2B5EF4-FFF2-40B4-BE49-F238E27FC236}">
                      <a16:creationId xmlns:a16="http://schemas.microsoft.com/office/drawing/2014/main" id="{4584513A-2572-467C-65BF-58F2C672ACDF}"/>
                    </a:ext>
                  </a:extLst>
                </p:cNvPr>
                <p:cNvGrpSpPr/>
                <p:nvPr/>
              </p:nvGrpSpPr>
              <p:grpSpPr>
                <a:xfrm>
                  <a:off x="247650" y="2114550"/>
                  <a:ext cx="336550" cy="2604770"/>
                  <a:chOff x="234950" y="2114550"/>
                  <a:chExt cx="336550" cy="2604770"/>
                </a:xfrm>
              </p:grpSpPr>
              <p:sp>
                <p:nvSpPr>
                  <p:cNvPr id="571" name="직사각형 7">
                    <a:extLst>
                      <a:ext uri="{FF2B5EF4-FFF2-40B4-BE49-F238E27FC236}">
                        <a16:creationId xmlns:a16="http://schemas.microsoft.com/office/drawing/2014/main" id="{68E10E85-55D4-CBBE-4D74-46D673577F05}"/>
                      </a:ext>
                    </a:extLst>
                  </p:cNvPr>
                  <p:cNvSpPr/>
                  <p:nvPr/>
                </p:nvSpPr>
                <p:spPr>
                  <a:xfrm>
                    <a:off x="234950" y="2114550"/>
                    <a:ext cx="336550" cy="27305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lIns="0" rIns="0" rtlCol="0" anchor="ctr"/>
                  <a:lstStyle/>
                  <a:p>
                    <a:pPr algn="ctr"/>
                    <a:r>
                      <a:rPr lang="en-US" altLang="ko-KR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vb1</a:t>
                    </a:r>
                    <a:endParaRPr lang="ko-KR" altLang="en-US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72" name="직사각형 8">
                    <a:extLst>
                      <a:ext uri="{FF2B5EF4-FFF2-40B4-BE49-F238E27FC236}">
                        <a16:creationId xmlns:a16="http://schemas.microsoft.com/office/drawing/2014/main" id="{E461E22D-09BE-A0DE-5A8E-F92AD6F78D2A}"/>
                      </a:ext>
                    </a:extLst>
                  </p:cNvPr>
                  <p:cNvSpPr/>
                  <p:nvPr/>
                </p:nvSpPr>
                <p:spPr>
                  <a:xfrm>
                    <a:off x="234950" y="2399665"/>
                    <a:ext cx="336550" cy="27305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lIns="0" rIns="0" rtlCol="0" anchor="ctr"/>
                  <a:lstStyle/>
                  <a:p>
                    <a:pPr algn="ctr"/>
                    <a:r>
                      <a:rPr lang="en-US" altLang="ko-KR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vb2</a:t>
                    </a:r>
                    <a:endParaRPr lang="ko-KR" altLang="en-US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73" name="직사각형 9">
                    <a:extLst>
                      <a:ext uri="{FF2B5EF4-FFF2-40B4-BE49-F238E27FC236}">
                        <a16:creationId xmlns:a16="http://schemas.microsoft.com/office/drawing/2014/main" id="{831CBDAC-0592-CB3B-FD0A-34FA1F571E33}"/>
                      </a:ext>
                    </a:extLst>
                  </p:cNvPr>
                  <p:cNvSpPr/>
                  <p:nvPr/>
                </p:nvSpPr>
                <p:spPr>
                  <a:xfrm>
                    <a:off x="234950" y="2812415"/>
                    <a:ext cx="336550" cy="27305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lIns="0" rIns="0" rtlCol="0" anchor="ctr"/>
                  <a:lstStyle/>
                  <a:p>
                    <a:pPr algn="ctr"/>
                    <a:r>
                      <a:rPr lang="en-US" altLang="ko-KR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vb3</a:t>
                    </a:r>
                    <a:endParaRPr lang="ko-KR" altLang="en-US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74" name="직사각형 10">
                    <a:extLst>
                      <a:ext uri="{FF2B5EF4-FFF2-40B4-BE49-F238E27FC236}">
                        <a16:creationId xmlns:a16="http://schemas.microsoft.com/office/drawing/2014/main" id="{CDC247CB-4393-D2B8-A53E-8D66A568A42C}"/>
                      </a:ext>
                    </a:extLst>
                  </p:cNvPr>
                  <p:cNvSpPr/>
                  <p:nvPr/>
                </p:nvSpPr>
                <p:spPr>
                  <a:xfrm>
                    <a:off x="234950" y="3243580"/>
                    <a:ext cx="336550" cy="27305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lIns="0" rIns="0" rtlCol="0" anchor="ctr"/>
                  <a:lstStyle/>
                  <a:p>
                    <a:pPr algn="ctr"/>
                    <a:r>
                      <a:rPr lang="en-US" altLang="ko-KR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vb4</a:t>
                    </a:r>
                    <a:endParaRPr lang="ko-KR" altLang="en-US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75" name="직사각형 11">
                    <a:extLst>
                      <a:ext uri="{FF2B5EF4-FFF2-40B4-BE49-F238E27FC236}">
                        <a16:creationId xmlns:a16="http://schemas.microsoft.com/office/drawing/2014/main" id="{A7DA10F8-2042-F044-AC7A-3A235ACCAD20}"/>
                      </a:ext>
                    </a:extLst>
                  </p:cNvPr>
                  <p:cNvSpPr/>
                  <p:nvPr/>
                </p:nvSpPr>
                <p:spPr>
                  <a:xfrm>
                    <a:off x="234950" y="3636645"/>
                    <a:ext cx="336550" cy="27305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lIns="0" rIns="0" rtlCol="0" anchor="ctr"/>
                  <a:lstStyle/>
                  <a:p>
                    <a:pPr algn="ctr"/>
                    <a:r>
                      <a:rPr lang="en-US" altLang="ko-KR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vb5</a:t>
                    </a:r>
                    <a:endParaRPr lang="ko-KR" altLang="en-US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76" name="직사각형 12">
                    <a:extLst>
                      <a:ext uri="{FF2B5EF4-FFF2-40B4-BE49-F238E27FC236}">
                        <a16:creationId xmlns:a16="http://schemas.microsoft.com/office/drawing/2014/main" id="{A1B846A6-10E0-A542-9DB3-D5F770B12019}"/>
                      </a:ext>
                    </a:extLst>
                  </p:cNvPr>
                  <p:cNvSpPr/>
                  <p:nvPr/>
                </p:nvSpPr>
                <p:spPr>
                  <a:xfrm>
                    <a:off x="234950" y="4046855"/>
                    <a:ext cx="336550" cy="27305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lIns="0" rIns="0" rtlCol="0" anchor="ctr"/>
                  <a:lstStyle/>
                  <a:p>
                    <a:pPr algn="ctr"/>
                    <a:r>
                      <a:rPr lang="en-US" altLang="ko-KR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vb6</a:t>
                    </a:r>
                    <a:endParaRPr lang="ko-KR" altLang="en-US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77" name="직사각형 13">
                    <a:extLst>
                      <a:ext uri="{FF2B5EF4-FFF2-40B4-BE49-F238E27FC236}">
                        <a16:creationId xmlns:a16="http://schemas.microsoft.com/office/drawing/2014/main" id="{4B66FEF3-DABA-F765-152B-E980C36EFC53}"/>
                      </a:ext>
                    </a:extLst>
                  </p:cNvPr>
                  <p:cNvSpPr/>
                  <p:nvPr/>
                </p:nvSpPr>
                <p:spPr>
                  <a:xfrm>
                    <a:off x="234950" y="4446270"/>
                    <a:ext cx="336550" cy="27305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lIns="0" rIns="0" rtlCol="0" anchor="ctr"/>
                  <a:lstStyle/>
                  <a:p>
                    <a:pPr algn="ctr"/>
                    <a:r>
                      <a:rPr lang="en-US" altLang="ko-KR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vb7</a:t>
                    </a:r>
                    <a:endParaRPr lang="ko-KR" altLang="en-US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543" name="직사각형 15">
                  <a:extLst>
                    <a:ext uri="{FF2B5EF4-FFF2-40B4-BE49-F238E27FC236}">
                      <a16:creationId xmlns:a16="http://schemas.microsoft.com/office/drawing/2014/main" id="{3F4DC239-3E02-4E25-297B-0CC97F5A4C45}"/>
                    </a:ext>
                  </a:extLst>
                </p:cNvPr>
                <p:cNvSpPr/>
                <p:nvPr/>
              </p:nvSpPr>
              <p:spPr>
                <a:xfrm>
                  <a:off x="584200" y="4756150"/>
                  <a:ext cx="171450" cy="27305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rIns="0" rtlCol="0" anchor="ctr"/>
                <a:lstStyle/>
                <a:p>
                  <a:pPr algn="ctr"/>
                  <a:r>
                    <a:rPr lang="en-US" altLang="ko-KR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A</a:t>
                  </a:r>
                  <a:endParaRPr lang="ko-KR" alt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4" name="직사각형 16">
                  <a:extLst>
                    <a:ext uri="{FF2B5EF4-FFF2-40B4-BE49-F238E27FC236}">
                      <a16:creationId xmlns:a16="http://schemas.microsoft.com/office/drawing/2014/main" id="{5B759118-6FAA-E884-FC55-B552F9B1CAC6}"/>
                    </a:ext>
                  </a:extLst>
                </p:cNvPr>
                <p:cNvSpPr/>
                <p:nvPr/>
              </p:nvSpPr>
              <p:spPr>
                <a:xfrm>
                  <a:off x="783461" y="4756150"/>
                  <a:ext cx="171450" cy="27305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rIns="0" rtlCol="0" anchor="ctr"/>
                <a:lstStyle/>
                <a:p>
                  <a:pPr algn="ctr"/>
                  <a:r>
                    <a:rPr lang="en-US" altLang="ko-KR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B</a:t>
                  </a:r>
                  <a:endParaRPr lang="ko-KR" alt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5" name="직사각형 17">
                  <a:extLst>
                    <a:ext uri="{FF2B5EF4-FFF2-40B4-BE49-F238E27FC236}">
                      <a16:creationId xmlns:a16="http://schemas.microsoft.com/office/drawing/2014/main" id="{7C9179E4-605E-706C-991B-1897B67C4246}"/>
                    </a:ext>
                  </a:extLst>
                </p:cNvPr>
                <p:cNvSpPr/>
                <p:nvPr/>
              </p:nvSpPr>
              <p:spPr>
                <a:xfrm>
                  <a:off x="982722" y="4756150"/>
                  <a:ext cx="171450" cy="27305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rIns="0" rtlCol="0" anchor="ctr"/>
                <a:lstStyle/>
                <a:p>
                  <a:pPr algn="ctr"/>
                  <a:r>
                    <a:rPr lang="en-US" altLang="ko-KR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C</a:t>
                  </a:r>
                  <a:endParaRPr lang="ko-KR" alt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6" name="직사각형 18">
                  <a:extLst>
                    <a:ext uri="{FF2B5EF4-FFF2-40B4-BE49-F238E27FC236}">
                      <a16:creationId xmlns:a16="http://schemas.microsoft.com/office/drawing/2014/main" id="{584F40C7-504A-BBFD-4EAD-A2483CEF4664}"/>
                    </a:ext>
                  </a:extLst>
                </p:cNvPr>
                <p:cNvSpPr/>
                <p:nvPr/>
              </p:nvSpPr>
              <p:spPr>
                <a:xfrm>
                  <a:off x="1155700" y="4756150"/>
                  <a:ext cx="171450" cy="27305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rIns="0" rtlCol="0" anchor="ctr"/>
                <a:lstStyle/>
                <a:p>
                  <a:pPr algn="ctr"/>
                  <a:r>
                    <a:rPr lang="en-US" altLang="ko-KR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D</a:t>
                  </a:r>
                  <a:endParaRPr lang="ko-KR" alt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7" name="직사각형 19">
                  <a:extLst>
                    <a:ext uri="{FF2B5EF4-FFF2-40B4-BE49-F238E27FC236}">
                      <a16:creationId xmlns:a16="http://schemas.microsoft.com/office/drawing/2014/main" id="{55E846C5-B70C-21FA-C6AF-AA5F668E0A22}"/>
                    </a:ext>
                  </a:extLst>
                </p:cNvPr>
                <p:cNvSpPr/>
                <p:nvPr/>
              </p:nvSpPr>
              <p:spPr>
                <a:xfrm>
                  <a:off x="1336794" y="4756150"/>
                  <a:ext cx="171450" cy="27305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rIns="0" rtlCol="0" anchor="ctr"/>
                <a:lstStyle/>
                <a:p>
                  <a:pPr algn="ctr"/>
                  <a:r>
                    <a:rPr lang="en-US" altLang="ko-KR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A</a:t>
                  </a:r>
                  <a:endParaRPr lang="ko-KR" alt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8" name="직사각형 20">
                  <a:extLst>
                    <a:ext uri="{FF2B5EF4-FFF2-40B4-BE49-F238E27FC236}">
                      <a16:creationId xmlns:a16="http://schemas.microsoft.com/office/drawing/2014/main" id="{DF60B991-C71F-CD14-33EA-4B00D93367BE}"/>
                    </a:ext>
                  </a:extLst>
                </p:cNvPr>
                <p:cNvSpPr/>
                <p:nvPr/>
              </p:nvSpPr>
              <p:spPr>
                <a:xfrm>
                  <a:off x="1529705" y="4756150"/>
                  <a:ext cx="171450" cy="27305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rIns="0" rtlCol="0" anchor="ctr"/>
                <a:lstStyle/>
                <a:p>
                  <a:pPr algn="ctr"/>
                  <a:r>
                    <a:rPr lang="en-US" altLang="ko-KR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B</a:t>
                  </a:r>
                  <a:endParaRPr lang="ko-KR" alt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9" name="직사각형 21">
                  <a:extLst>
                    <a:ext uri="{FF2B5EF4-FFF2-40B4-BE49-F238E27FC236}">
                      <a16:creationId xmlns:a16="http://schemas.microsoft.com/office/drawing/2014/main" id="{63BC5225-7696-3DB7-EE83-601385D2E4E0}"/>
                    </a:ext>
                  </a:extLst>
                </p:cNvPr>
                <p:cNvSpPr/>
                <p:nvPr/>
              </p:nvSpPr>
              <p:spPr>
                <a:xfrm>
                  <a:off x="1722616" y="4756150"/>
                  <a:ext cx="171450" cy="27305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rIns="0" rtlCol="0" anchor="ctr"/>
                <a:lstStyle/>
                <a:p>
                  <a:pPr algn="ctr"/>
                  <a:r>
                    <a:rPr lang="en-US" altLang="ko-KR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C</a:t>
                  </a:r>
                  <a:endParaRPr lang="ko-KR" alt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0" name="직사각형 22">
                  <a:extLst>
                    <a:ext uri="{FF2B5EF4-FFF2-40B4-BE49-F238E27FC236}">
                      <a16:creationId xmlns:a16="http://schemas.microsoft.com/office/drawing/2014/main" id="{D4E7EFFD-A46D-0AEA-FFA6-06A8A262CCBB}"/>
                    </a:ext>
                  </a:extLst>
                </p:cNvPr>
                <p:cNvSpPr/>
                <p:nvPr/>
              </p:nvSpPr>
              <p:spPr>
                <a:xfrm>
                  <a:off x="1921877" y="4756150"/>
                  <a:ext cx="171450" cy="27305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rIns="0" rtlCol="0" anchor="ctr"/>
                <a:lstStyle/>
                <a:p>
                  <a:pPr algn="ctr"/>
                  <a:r>
                    <a:rPr lang="en-US" altLang="ko-KR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D</a:t>
                  </a:r>
                  <a:endParaRPr lang="ko-KR" alt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1" name="직사각형 23">
                  <a:extLst>
                    <a:ext uri="{FF2B5EF4-FFF2-40B4-BE49-F238E27FC236}">
                      <a16:creationId xmlns:a16="http://schemas.microsoft.com/office/drawing/2014/main" id="{9EDF9393-B8B7-1FAD-BB25-EA635E8CDCF4}"/>
                    </a:ext>
                  </a:extLst>
                </p:cNvPr>
                <p:cNvSpPr/>
                <p:nvPr/>
              </p:nvSpPr>
              <p:spPr>
                <a:xfrm>
                  <a:off x="2121138" y="4756150"/>
                  <a:ext cx="171450" cy="27305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rIns="0" rtlCol="0" anchor="ctr"/>
                <a:lstStyle/>
                <a:p>
                  <a:pPr algn="ctr"/>
                  <a:r>
                    <a:rPr lang="en-US" altLang="ko-KR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3A</a:t>
                  </a:r>
                  <a:endParaRPr lang="ko-KR" alt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2" name="직사각형 24">
                  <a:extLst>
                    <a:ext uri="{FF2B5EF4-FFF2-40B4-BE49-F238E27FC236}">
                      <a16:creationId xmlns:a16="http://schemas.microsoft.com/office/drawing/2014/main" id="{3568CD68-47B6-8C07-E0ED-F27004CCB681}"/>
                    </a:ext>
                  </a:extLst>
                </p:cNvPr>
                <p:cNvSpPr/>
                <p:nvPr/>
              </p:nvSpPr>
              <p:spPr>
                <a:xfrm>
                  <a:off x="2345799" y="4756150"/>
                  <a:ext cx="171450" cy="27305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rIns="0" rtlCol="0" anchor="ctr"/>
                <a:lstStyle/>
                <a:p>
                  <a:pPr algn="ctr"/>
                  <a:r>
                    <a:rPr lang="en-US" altLang="ko-KR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3B</a:t>
                  </a:r>
                  <a:endParaRPr lang="ko-KR" alt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3" name="직사각형 25">
                  <a:extLst>
                    <a:ext uri="{FF2B5EF4-FFF2-40B4-BE49-F238E27FC236}">
                      <a16:creationId xmlns:a16="http://schemas.microsoft.com/office/drawing/2014/main" id="{C1EAFD0C-74D0-2EBC-C679-C5AF667CBAC4}"/>
                    </a:ext>
                  </a:extLst>
                </p:cNvPr>
                <p:cNvSpPr/>
                <p:nvPr/>
              </p:nvSpPr>
              <p:spPr>
                <a:xfrm>
                  <a:off x="2557760" y="4756150"/>
                  <a:ext cx="171450" cy="27305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rIns="0" rtlCol="0" anchor="ctr"/>
                <a:lstStyle/>
                <a:p>
                  <a:pPr algn="ctr"/>
                  <a:r>
                    <a:rPr lang="en-US" altLang="ko-KR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3C</a:t>
                  </a:r>
                  <a:endParaRPr lang="ko-KR" alt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4" name="직사각형 26">
                  <a:extLst>
                    <a:ext uri="{FF2B5EF4-FFF2-40B4-BE49-F238E27FC236}">
                      <a16:creationId xmlns:a16="http://schemas.microsoft.com/office/drawing/2014/main" id="{0558CF7A-EA7B-1503-C4E2-CD73A80A65A3}"/>
                    </a:ext>
                  </a:extLst>
                </p:cNvPr>
                <p:cNvSpPr/>
                <p:nvPr/>
              </p:nvSpPr>
              <p:spPr>
                <a:xfrm>
                  <a:off x="2776071" y="4756150"/>
                  <a:ext cx="171450" cy="27305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rIns="0" rtlCol="0" anchor="ctr"/>
                <a:lstStyle/>
                <a:p>
                  <a:pPr algn="ctr"/>
                  <a:r>
                    <a:rPr lang="en-US" altLang="ko-KR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3D</a:t>
                  </a:r>
                  <a:endParaRPr lang="ko-KR" alt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5" name="직사각형 27">
                  <a:extLst>
                    <a:ext uri="{FF2B5EF4-FFF2-40B4-BE49-F238E27FC236}">
                      <a16:creationId xmlns:a16="http://schemas.microsoft.com/office/drawing/2014/main" id="{5935BE63-AF9C-CF9A-402A-893CA73B0554}"/>
                    </a:ext>
                  </a:extLst>
                </p:cNvPr>
                <p:cNvSpPr/>
                <p:nvPr/>
              </p:nvSpPr>
              <p:spPr>
                <a:xfrm>
                  <a:off x="2975332" y="4756150"/>
                  <a:ext cx="171450" cy="27305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rIns="0" rtlCol="0" anchor="ctr"/>
                <a:lstStyle/>
                <a:p>
                  <a:pPr algn="ctr"/>
                  <a:r>
                    <a:rPr lang="en-US" altLang="ko-KR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A</a:t>
                  </a:r>
                  <a:endParaRPr lang="ko-KR" alt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6" name="직사각형 28">
                  <a:extLst>
                    <a:ext uri="{FF2B5EF4-FFF2-40B4-BE49-F238E27FC236}">
                      <a16:creationId xmlns:a16="http://schemas.microsoft.com/office/drawing/2014/main" id="{6DB9B98D-8C47-FC68-39B4-8A01912B0ECD}"/>
                    </a:ext>
                  </a:extLst>
                </p:cNvPr>
                <p:cNvSpPr/>
                <p:nvPr/>
              </p:nvSpPr>
              <p:spPr>
                <a:xfrm>
                  <a:off x="3174593" y="4756150"/>
                  <a:ext cx="171450" cy="27305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rIns="0" rtlCol="0" anchor="ctr"/>
                <a:lstStyle/>
                <a:p>
                  <a:pPr algn="ctr"/>
                  <a:r>
                    <a:rPr lang="en-US" altLang="ko-KR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B</a:t>
                  </a:r>
                  <a:endParaRPr lang="ko-KR" alt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7" name="직사각형 29">
                  <a:extLst>
                    <a:ext uri="{FF2B5EF4-FFF2-40B4-BE49-F238E27FC236}">
                      <a16:creationId xmlns:a16="http://schemas.microsoft.com/office/drawing/2014/main" id="{C21D612D-4BA3-AC4B-F0B2-93846DAE4A2E}"/>
                    </a:ext>
                  </a:extLst>
                </p:cNvPr>
                <p:cNvSpPr/>
                <p:nvPr/>
              </p:nvSpPr>
              <p:spPr>
                <a:xfrm>
                  <a:off x="3373854" y="4756150"/>
                  <a:ext cx="171450" cy="27305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rIns="0" rtlCol="0" anchor="ctr"/>
                <a:lstStyle/>
                <a:p>
                  <a:pPr algn="ctr"/>
                  <a:r>
                    <a:rPr lang="en-US" altLang="ko-KR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C</a:t>
                  </a:r>
                  <a:endParaRPr lang="ko-KR" alt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8" name="직사각형 30">
                  <a:extLst>
                    <a:ext uri="{FF2B5EF4-FFF2-40B4-BE49-F238E27FC236}">
                      <a16:creationId xmlns:a16="http://schemas.microsoft.com/office/drawing/2014/main" id="{12AF3CE6-1F8D-56CF-63D6-B6491CC6B300}"/>
                    </a:ext>
                  </a:extLst>
                </p:cNvPr>
                <p:cNvSpPr/>
                <p:nvPr/>
              </p:nvSpPr>
              <p:spPr>
                <a:xfrm>
                  <a:off x="3573115" y="4756150"/>
                  <a:ext cx="171450" cy="27305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rIns="0" rtlCol="0" anchor="ctr"/>
                <a:lstStyle/>
                <a:p>
                  <a:pPr algn="ctr"/>
                  <a:r>
                    <a:rPr lang="en-US" altLang="ko-KR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D</a:t>
                  </a:r>
                  <a:endParaRPr lang="ko-KR" alt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9" name="직사각형 31">
                  <a:extLst>
                    <a:ext uri="{FF2B5EF4-FFF2-40B4-BE49-F238E27FC236}">
                      <a16:creationId xmlns:a16="http://schemas.microsoft.com/office/drawing/2014/main" id="{35714317-B82A-5E58-090B-6633C15BB55C}"/>
                    </a:ext>
                  </a:extLst>
                </p:cNvPr>
                <p:cNvSpPr/>
                <p:nvPr/>
              </p:nvSpPr>
              <p:spPr>
                <a:xfrm>
                  <a:off x="3753326" y="4756150"/>
                  <a:ext cx="171450" cy="27305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rIns="0" rtlCol="0" anchor="ctr"/>
                <a:lstStyle/>
                <a:p>
                  <a:pPr algn="ctr"/>
                  <a:r>
                    <a:rPr lang="en-US" altLang="ko-KR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5A</a:t>
                  </a:r>
                  <a:endParaRPr lang="ko-KR" alt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0" name="직사각형 32">
                  <a:extLst>
                    <a:ext uri="{FF2B5EF4-FFF2-40B4-BE49-F238E27FC236}">
                      <a16:creationId xmlns:a16="http://schemas.microsoft.com/office/drawing/2014/main" id="{89745133-0410-B2EC-5D15-6F44B346B4B6}"/>
                    </a:ext>
                  </a:extLst>
                </p:cNvPr>
                <p:cNvSpPr/>
                <p:nvPr/>
              </p:nvSpPr>
              <p:spPr>
                <a:xfrm>
                  <a:off x="3946237" y="4756150"/>
                  <a:ext cx="171450" cy="27305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rIns="0" rtlCol="0" anchor="ctr"/>
                <a:lstStyle/>
                <a:p>
                  <a:pPr algn="ctr"/>
                  <a:r>
                    <a:rPr lang="en-US" altLang="ko-KR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5B</a:t>
                  </a:r>
                  <a:endParaRPr lang="ko-KR" alt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1" name="직사각형 33">
                  <a:extLst>
                    <a:ext uri="{FF2B5EF4-FFF2-40B4-BE49-F238E27FC236}">
                      <a16:creationId xmlns:a16="http://schemas.microsoft.com/office/drawing/2014/main" id="{E73C8E2F-C204-A51C-BF94-1164D4BCFCB5}"/>
                    </a:ext>
                  </a:extLst>
                </p:cNvPr>
                <p:cNvSpPr/>
                <p:nvPr/>
              </p:nvSpPr>
              <p:spPr>
                <a:xfrm>
                  <a:off x="4126448" y="4756150"/>
                  <a:ext cx="171450" cy="27305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rIns="0" rtlCol="0" anchor="ctr"/>
                <a:lstStyle/>
                <a:p>
                  <a:pPr algn="ctr"/>
                  <a:r>
                    <a:rPr lang="en-US" altLang="ko-KR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5C</a:t>
                  </a:r>
                  <a:endParaRPr lang="ko-KR" alt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2" name="직사각형 34">
                  <a:extLst>
                    <a:ext uri="{FF2B5EF4-FFF2-40B4-BE49-F238E27FC236}">
                      <a16:creationId xmlns:a16="http://schemas.microsoft.com/office/drawing/2014/main" id="{945DD5E4-DBBE-C382-36BB-FCF241DAF710}"/>
                    </a:ext>
                  </a:extLst>
                </p:cNvPr>
                <p:cNvSpPr/>
                <p:nvPr/>
              </p:nvSpPr>
              <p:spPr>
                <a:xfrm>
                  <a:off x="4319359" y="4756150"/>
                  <a:ext cx="171450" cy="27305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rIns="0" rtlCol="0" anchor="ctr"/>
                <a:lstStyle/>
                <a:p>
                  <a:pPr algn="ctr"/>
                  <a:r>
                    <a:rPr lang="en-US" altLang="ko-KR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5D</a:t>
                  </a:r>
                  <a:endParaRPr lang="ko-KR" alt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3" name="직사각형 37">
                  <a:extLst>
                    <a:ext uri="{FF2B5EF4-FFF2-40B4-BE49-F238E27FC236}">
                      <a16:creationId xmlns:a16="http://schemas.microsoft.com/office/drawing/2014/main" id="{1F13966C-9716-9104-68C9-4D3B0BEDA125}"/>
                    </a:ext>
                  </a:extLst>
                </p:cNvPr>
                <p:cNvSpPr/>
                <p:nvPr/>
              </p:nvSpPr>
              <p:spPr>
                <a:xfrm>
                  <a:off x="4531320" y="4756150"/>
                  <a:ext cx="171450" cy="27305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rIns="0" rtlCol="0" anchor="ctr"/>
                <a:lstStyle/>
                <a:p>
                  <a:pPr algn="ctr"/>
                  <a:r>
                    <a:rPr lang="en-US" altLang="ko-KR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6A</a:t>
                  </a:r>
                  <a:endParaRPr lang="ko-KR" alt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4" name="직사각형 38">
                  <a:extLst>
                    <a:ext uri="{FF2B5EF4-FFF2-40B4-BE49-F238E27FC236}">
                      <a16:creationId xmlns:a16="http://schemas.microsoft.com/office/drawing/2014/main" id="{C19C11B1-2CF4-D764-76A3-A39F2A457154}"/>
                    </a:ext>
                  </a:extLst>
                </p:cNvPr>
                <p:cNvSpPr/>
                <p:nvPr/>
              </p:nvSpPr>
              <p:spPr>
                <a:xfrm>
                  <a:off x="4768681" y="4756150"/>
                  <a:ext cx="171450" cy="27305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rIns="0" rtlCol="0" anchor="ctr"/>
                <a:lstStyle/>
                <a:p>
                  <a:pPr algn="ctr"/>
                  <a:r>
                    <a:rPr lang="en-US" altLang="ko-KR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6B</a:t>
                  </a:r>
                  <a:endParaRPr lang="ko-KR" alt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5" name="직사각형 39">
                  <a:extLst>
                    <a:ext uri="{FF2B5EF4-FFF2-40B4-BE49-F238E27FC236}">
                      <a16:creationId xmlns:a16="http://schemas.microsoft.com/office/drawing/2014/main" id="{64E17BD2-F27A-1F17-9439-D49BA0183269}"/>
                    </a:ext>
                  </a:extLst>
                </p:cNvPr>
                <p:cNvSpPr/>
                <p:nvPr/>
              </p:nvSpPr>
              <p:spPr>
                <a:xfrm>
                  <a:off x="5018742" y="4756150"/>
                  <a:ext cx="171450" cy="27305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rIns="0" rtlCol="0" anchor="ctr"/>
                <a:lstStyle/>
                <a:p>
                  <a:pPr algn="ctr"/>
                  <a:r>
                    <a:rPr lang="en-US" altLang="ko-KR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6C</a:t>
                  </a:r>
                  <a:endParaRPr lang="ko-KR" alt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6" name="직사각형 40">
                  <a:extLst>
                    <a:ext uri="{FF2B5EF4-FFF2-40B4-BE49-F238E27FC236}">
                      <a16:creationId xmlns:a16="http://schemas.microsoft.com/office/drawing/2014/main" id="{578DC377-60F5-CAF7-E3C1-83CEB2190E6A}"/>
                    </a:ext>
                  </a:extLst>
                </p:cNvPr>
                <p:cNvSpPr/>
                <p:nvPr/>
              </p:nvSpPr>
              <p:spPr>
                <a:xfrm>
                  <a:off x="5256103" y="4756150"/>
                  <a:ext cx="171450" cy="27305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rIns="0" rtlCol="0" anchor="ctr"/>
                <a:lstStyle/>
                <a:p>
                  <a:pPr algn="ctr"/>
                  <a:r>
                    <a:rPr lang="en-US" altLang="ko-KR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6D</a:t>
                  </a:r>
                  <a:endParaRPr lang="ko-KR" alt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7" name="직사각형 41">
                  <a:extLst>
                    <a:ext uri="{FF2B5EF4-FFF2-40B4-BE49-F238E27FC236}">
                      <a16:creationId xmlns:a16="http://schemas.microsoft.com/office/drawing/2014/main" id="{20FDE2BA-CBF0-74B0-D3EF-314696B6B205}"/>
                    </a:ext>
                  </a:extLst>
                </p:cNvPr>
                <p:cNvSpPr/>
                <p:nvPr/>
              </p:nvSpPr>
              <p:spPr>
                <a:xfrm>
                  <a:off x="5449014" y="4756150"/>
                  <a:ext cx="171450" cy="27305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rIns="0" rtlCol="0" anchor="ctr"/>
                <a:lstStyle/>
                <a:p>
                  <a:pPr algn="ctr"/>
                  <a:r>
                    <a:rPr lang="en-US" altLang="ko-KR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7A</a:t>
                  </a:r>
                  <a:endParaRPr lang="ko-KR" alt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8" name="직사각형 42">
                  <a:extLst>
                    <a:ext uri="{FF2B5EF4-FFF2-40B4-BE49-F238E27FC236}">
                      <a16:creationId xmlns:a16="http://schemas.microsoft.com/office/drawing/2014/main" id="{B2509E67-A417-77BC-086C-CB1FC7A4C3F5}"/>
                    </a:ext>
                  </a:extLst>
                </p:cNvPr>
                <p:cNvSpPr/>
                <p:nvPr/>
              </p:nvSpPr>
              <p:spPr>
                <a:xfrm>
                  <a:off x="5616525" y="4756150"/>
                  <a:ext cx="171450" cy="27305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rIns="0" rtlCol="0" anchor="ctr"/>
                <a:lstStyle/>
                <a:p>
                  <a:pPr algn="ctr"/>
                  <a:r>
                    <a:rPr lang="en-US" altLang="ko-KR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7B</a:t>
                  </a:r>
                  <a:endParaRPr lang="ko-KR" alt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9" name="직사각형 43">
                  <a:extLst>
                    <a:ext uri="{FF2B5EF4-FFF2-40B4-BE49-F238E27FC236}">
                      <a16:creationId xmlns:a16="http://schemas.microsoft.com/office/drawing/2014/main" id="{99FBD39C-B081-1338-21C0-49A7F93967F3}"/>
                    </a:ext>
                  </a:extLst>
                </p:cNvPr>
                <p:cNvSpPr/>
                <p:nvPr/>
              </p:nvSpPr>
              <p:spPr>
                <a:xfrm>
                  <a:off x="5784036" y="4756150"/>
                  <a:ext cx="171450" cy="27305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rIns="0" rtlCol="0" anchor="ctr"/>
                <a:lstStyle/>
                <a:p>
                  <a:pPr algn="ctr"/>
                  <a:r>
                    <a:rPr lang="en-US" altLang="ko-KR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7C</a:t>
                  </a:r>
                  <a:endParaRPr lang="ko-KR" alt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70" name="직사각형 44">
                  <a:extLst>
                    <a:ext uri="{FF2B5EF4-FFF2-40B4-BE49-F238E27FC236}">
                      <a16:creationId xmlns:a16="http://schemas.microsoft.com/office/drawing/2014/main" id="{7C4F126A-7E37-1681-BB9A-A5923EE1D721}"/>
                    </a:ext>
                  </a:extLst>
                </p:cNvPr>
                <p:cNvSpPr/>
                <p:nvPr/>
              </p:nvSpPr>
              <p:spPr>
                <a:xfrm>
                  <a:off x="5945186" y="4756150"/>
                  <a:ext cx="171450" cy="27305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rIns="0" rtlCol="0" anchor="ctr"/>
                <a:lstStyle/>
                <a:p>
                  <a:pPr algn="ctr"/>
                  <a:r>
                    <a:rPr lang="en-US" altLang="ko-KR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7D</a:t>
                  </a:r>
                  <a:endParaRPr lang="ko-KR" alt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01" name="Group 91">
                <a:extLst>
                  <a:ext uri="{FF2B5EF4-FFF2-40B4-BE49-F238E27FC236}">
                    <a16:creationId xmlns:a16="http://schemas.microsoft.com/office/drawing/2014/main" id="{4FB3B942-86D8-D579-1992-6360C09DFBD8}"/>
                  </a:ext>
                </a:extLst>
              </p:cNvPr>
              <p:cNvGrpSpPr/>
              <p:nvPr/>
            </p:nvGrpSpPr>
            <p:grpSpPr>
              <a:xfrm>
                <a:off x="279018" y="5227036"/>
                <a:ext cx="5863364" cy="2922838"/>
                <a:chOff x="247650" y="5289017"/>
                <a:chExt cx="5863364" cy="2922838"/>
              </a:xfrm>
            </p:grpSpPr>
            <p:grpSp>
              <p:nvGrpSpPr>
                <p:cNvPr id="502" name="Group 82">
                  <a:extLst>
                    <a:ext uri="{FF2B5EF4-FFF2-40B4-BE49-F238E27FC236}">
                      <a16:creationId xmlns:a16="http://schemas.microsoft.com/office/drawing/2014/main" id="{7FD32A81-D603-B496-03BC-BDE33F8B2E4C}"/>
                    </a:ext>
                  </a:extLst>
                </p:cNvPr>
                <p:cNvGrpSpPr/>
                <p:nvPr/>
              </p:nvGrpSpPr>
              <p:grpSpPr>
                <a:xfrm>
                  <a:off x="581071" y="5289017"/>
                  <a:ext cx="5529943" cy="2922838"/>
                  <a:chOff x="581071" y="5289017"/>
                  <a:chExt cx="5529943" cy="2922838"/>
                </a:xfrm>
              </p:grpSpPr>
              <p:grpSp>
                <p:nvGrpSpPr>
                  <p:cNvPr id="511" name="그룹 73">
                    <a:extLst>
                      <a:ext uri="{FF2B5EF4-FFF2-40B4-BE49-F238E27FC236}">
                        <a16:creationId xmlns:a16="http://schemas.microsoft.com/office/drawing/2014/main" id="{C98F8F84-526F-4B36-13FB-16ACC4B5D42E}"/>
                      </a:ext>
                    </a:extLst>
                  </p:cNvPr>
                  <p:cNvGrpSpPr/>
                  <p:nvPr/>
                </p:nvGrpSpPr>
                <p:grpSpPr>
                  <a:xfrm>
                    <a:off x="598874" y="7938805"/>
                    <a:ext cx="5494336" cy="273050"/>
                    <a:chOff x="6119058" y="4756150"/>
                    <a:chExt cx="5494336" cy="273050"/>
                  </a:xfrm>
                </p:grpSpPr>
                <p:sp>
                  <p:nvSpPr>
                    <p:cNvPr id="513" name="직사각형 45">
                      <a:extLst>
                        <a:ext uri="{FF2B5EF4-FFF2-40B4-BE49-F238E27FC236}">
                          <a16:creationId xmlns:a16="http://schemas.microsoft.com/office/drawing/2014/main" id="{31D1BF99-ECF4-6077-F174-EAA9FCC76CB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6119058" y="4756150"/>
                      <a:ext cx="171450" cy="27305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lIns="0" rIns="0" rtlCol="0" anchor="ctr"/>
                    <a:lstStyle/>
                    <a:p>
                      <a:pPr algn="ctr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A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14" name="직사각형 46">
                      <a:extLst>
                        <a:ext uri="{FF2B5EF4-FFF2-40B4-BE49-F238E27FC236}">
                          <a16:creationId xmlns:a16="http://schemas.microsoft.com/office/drawing/2014/main" id="{5586D5AD-BD7F-427B-B8B1-27C81382153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6286569" y="4756150"/>
                      <a:ext cx="171450" cy="27305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lIns="0" rIns="0" rtlCol="0" anchor="ctr"/>
                    <a:lstStyle/>
                    <a:p>
                      <a:pPr algn="ctr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B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15" name="직사각형 47">
                      <a:extLst>
                        <a:ext uri="{FF2B5EF4-FFF2-40B4-BE49-F238E27FC236}">
                          <a16:creationId xmlns:a16="http://schemas.microsoft.com/office/drawing/2014/main" id="{E201A2A7-4DC5-E2A4-30A0-1A4FD4B5602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6466625" y="4756150"/>
                      <a:ext cx="171450" cy="27305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lIns="0" rIns="0" rtlCol="0" anchor="ctr"/>
                    <a:lstStyle/>
                    <a:p>
                      <a:pPr algn="ctr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C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16" name="직사각형 48">
                      <a:extLst>
                        <a:ext uri="{FF2B5EF4-FFF2-40B4-BE49-F238E27FC236}">
                          <a16:creationId xmlns:a16="http://schemas.microsoft.com/office/drawing/2014/main" id="{763B84E0-5A9D-D29A-2B8A-58CD445D275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6645953" y="4756150"/>
                      <a:ext cx="171450" cy="27305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lIns="0" rIns="0" rtlCol="0" anchor="ctr"/>
                    <a:lstStyle/>
                    <a:p>
                      <a:pPr algn="ctr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D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17" name="직사각형 49">
                      <a:extLst>
                        <a:ext uri="{FF2B5EF4-FFF2-40B4-BE49-F238E27FC236}">
                          <a16:creationId xmlns:a16="http://schemas.microsoft.com/office/drawing/2014/main" id="{502BDFEE-1DA2-186E-EC01-B8FCD69EBF9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6839747" y="4756150"/>
                      <a:ext cx="171450" cy="27305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lIns="0" rIns="0" rtlCol="0" anchor="ctr"/>
                    <a:lstStyle/>
                    <a:p>
                      <a:pPr algn="ctr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A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18" name="직사각형 50">
                      <a:extLst>
                        <a:ext uri="{FF2B5EF4-FFF2-40B4-BE49-F238E27FC236}">
                          <a16:creationId xmlns:a16="http://schemas.microsoft.com/office/drawing/2014/main" id="{6D67A3C1-9C8A-CE5B-FF4C-C1CCD6E77BE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026463" y="4756150"/>
                      <a:ext cx="171450" cy="27305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lIns="0" rIns="0" rtlCol="0" anchor="ctr"/>
                    <a:lstStyle/>
                    <a:p>
                      <a:pPr algn="ctr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B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19" name="직사각형 51">
                      <a:extLst>
                        <a:ext uri="{FF2B5EF4-FFF2-40B4-BE49-F238E27FC236}">
                          <a16:creationId xmlns:a16="http://schemas.microsoft.com/office/drawing/2014/main" id="{F35BF12D-38D9-967A-B37E-7E8709A8A11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219219" y="4756150"/>
                      <a:ext cx="171450" cy="27305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lIns="0" rIns="0" rtlCol="0" anchor="ctr"/>
                    <a:lstStyle/>
                    <a:p>
                      <a:pPr algn="ctr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C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20" name="직사각형 52">
                      <a:extLst>
                        <a:ext uri="{FF2B5EF4-FFF2-40B4-BE49-F238E27FC236}">
                          <a16:creationId xmlns:a16="http://schemas.microsoft.com/office/drawing/2014/main" id="{3EB04DC5-B642-A462-7A2A-C1E040C6960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12285" y="4756150"/>
                      <a:ext cx="171450" cy="27305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lIns="0" rIns="0" rtlCol="0" anchor="ctr"/>
                    <a:lstStyle/>
                    <a:p>
                      <a:pPr algn="ctr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D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21" name="직사각형 53">
                      <a:extLst>
                        <a:ext uri="{FF2B5EF4-FFF2-40B4-BE49-F238E27FC236}">
                          <a16:creationId xmlns:a16="http://schemas.microsoft.com/office/drawing/2014/main" id="{530D33F7-57ED-4F18-97CC-12459F10B5C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624402" y="4756150"/>
                      <a:ext cx="171450" cy="27305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lIns="0" rIns="0" rtlCol="0" anchor="ctr"/>
                    <a:lstStyle/>
                    <a:p>
                      <a:pPr algn="ctr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A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22" name="직사각형 54">
                      <a:extLst>
                        <a:ext uri="{FF2B5EF4-FFF2-40B4-BE49-F238E27FC236}">
                          <a16:creationId xmlns:a16="http://schemas.microsoft.com/office/drawing/2014/main" id="{346375AA-24F1-9895-D821-828AAEB34CC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842557" y="4756150"/>
                      <a:ext cx="171450" cy="27305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lIns="0" rIns="0" rtlCol="0" anchor="ctr"/>
                    <a:lstStyle/>
                    <a:p>
                      <a:pPr algn="ctr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B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23" name="직사각형 55">
                      <a:extLst>
                        <a:ext uri="{FF2B5EF4-FFF2-40B4-BE49-F238E27FC236}">
                          <a16:creationId xmlns:a16="http://schemas.microsoft.com/office/drawing/2014/main" id="{B247D30E-7FDF-6E40-176B-41C60078DC8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067218" y="4756150"/>
                      <a:ext cx="171450" cy="27305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lIns="0" rIns="0" rtlCol="0" anchor="ctr"/>
                    <a:lstStyle/>
                    <a:p>
                      <a:pPr algn="ctr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C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24" name="직사각형 56">
                      <a:extLst>
                        <a:ext uri="{FF2B5EF4-FFF2-40B4-BE49-F238E27FC236}">
                          <a16:creationId xmlns:a16="http://schemas.microsoft.com/office/drawing/2014/main" id="{F5A62EB7-DAB5-EE5F-432F-4DA25EB170B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285529" y="4756150"/>
                      <a:ext cx="171450" cy="27305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lIns="0" rIns="0" rtlCol="0" anchor="ctr"/>
                    <a:lstStyle/>
                    <a:p>
                      <a:pPr algn="ctr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D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25" name="직사각형 57">
                      <a:extLst>
                        <a:ext uri="{FF2B5EF4-FFF2-40B4-BE49-F238E27FC236}">
                          <a16:creationId xmlns:a16="http://schemas.microsoft.com/office/drawing/2014/main" id="{62781528-EF1D-7D34-2A01-D06207969E6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491140" y="4756150"/>
                      <a:ext cx="171450" cy="27305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lIns="0" rIns="0" rtlCol="0" anchor="ctr"/>
                    <a:lstStyle/>
                    <a:p>
                      <a:pPr algn="ctr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A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26" name="직사각형 58">
                      <a:extLst>
                        <a:ext uri="{FF2B5EF4-FFF2-40B4-BE49-F238E27FC236}">
                          <a16:creationId xmlns:a16="http://schemas.microsoft.com/office/drawing/2014/main" id="{81D13501-6399-B8B0-CD67-BFB429E64B2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684051" y="4756150"/>
                      <a:ext cx="171450" cy="27305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lIns="0" rIns="0" rtlCol="0" anchor="ctr"/>
                    <a:lstStyle/>
                    <a:p>
                      <a:pPr algn="ctr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B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27" name="직사각형 59">
                      <a:extLst>
                        <a:ext uri="{FF2B5EF4-FFF2-40B4-BE49-F238E27FC236}">
                          <a16:creationId xmlns:a16="http://schemas.microsoft.com/office/drawing/2014/main" id="{D07332C7-13D6-0A26-3CEB-496EA12B9B9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889662" y="4756150"/>
                      <a:ext cx="171450" cy="27305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lIns="0" rIns="0" rtlCol="0" anchor="ctr"/>
                    <a:lstStyle/>
                    <a:p>
                      <a:pPr algn="ctr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C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28" name="직사각형 60">
                      <a:extLst>
                        <a:ext uri="{FF2B5EF4-FFF2-40B4-BE49-F238E27FC236}">
                          <a16:creationId xmlns:a16="http://schemas.microsoft.com/office/drawing/2014/main" id="{D49C695B-A120-BE25-4C03-2FC2DF04706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069873" y="4756150"/>
                      <a:ext cx="171450" cy="27305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lIns="0" rIns="0" rtlCol="0" anchor="ctr"/>
                    <a:lstStyle/>
                    <a:p>
                      <a:pPr algn="ctr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D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29" name="직사각형 61">
                      <a:extLst>
                        <a:ext uri="{FF2B5EF4-FFF2-40B4-BE49-F238E27FC236}">
                          <a16:creationId xmlns:a16="http://schemas.microsoft.com/office/drawing/2014/main" id="{6738280C-779B-3B5D-8F59-19FFDE4511D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256434" y="4756150"/>
                      <a:ext cx="171450" cy="27305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lIns="0" rIns="0" rtlCol="0" anchor="ctr"/>
                    <a:lstStyle/>
                    <a:p>
                      <a:pPr algn="ctr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A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30" name="직사각형 62">
                      <a:extLst>
                        <a:ext uri="{FF2B5EF4-FFF2-40B4-BE49-F238E27FC236}">
                          <a16:creationId xmlns:a16="http://schemas.microsoft.com/office/drawing/2014/main" id="{CF837C37-F44F-1396-5340-0ACF59AEA57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442995" y="4756150"/>
                      <a:ext cx="171450" cy="27305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lIns="0" rIns="0" rtlCol="0" anchor="ctr"/>
                    <a:lstStyle/>
                    <a:p>
                      <a:pPr algn="ctr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B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31" name="직사각형 63">
                      <a:extLst>
                        <a:ext uri="{FF2B5EF4-FFF2-40B4-BE49-F238E27FC236}">
                          <a16:creationId xmlns:a16="http://schemas.microsoft.com/office/drawing/2014/main" id="{3942D1D0-6D29-2D3F-0DCA-5DD14F83B4E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635906" y="4756150"/>
                      <a:ext cx="171450" cy="27305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lIns="0" rIns="0" rtlCol="0" anchor="ctr"/>
                    <a:lstStyle/>
                    <a:p>
                      <a:pPr algn="ctr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C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32" name="직사각형 64">
                      <a:extLst>
                        <a:ext uri="{FF2B5EF4-FFF2-40B4-BE49-F238E27FC236}">
                          <a16:creationId xmlns:a16="http://schemas.microsoft.com/office/drawing/2014/main" id="{327DEC04-9F03-44C7-9382-4D4C74765F1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828817" y="4756150"/>
                      <a:ext cx="171450" cy="27305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lIns="0" rIns="0" rtlCol="0" anchor="ctr"/>
                    <a:lstStyle/>
                    <a:p>
                      <a:pPr algn="ctr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D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33" name="직사각형 65">
                      <a:extLst>
                        <a:ext uri="{FF2B5EF4-FFF2-40B4-BE49-F238E27FC236}">
                          <a16:creationId xmlns:a16="http://schemas.microsoft.com/office/drawing/2014/main" id="{571F1F88-CD8D-1421-580A-B2E5ED5C51D5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0040778" y="4756150"/>
                      <a:ext cx="171450" cy="27305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lIns="0" rIns="0" rtlCol="0" anchor="ctr"/>
                    <a:lstStyle/>
                    <a:p>
                      <a:pPr algn="ctr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A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34" name="직사각형 66">
                      <a:extLst>
                        <a:ext uri="{FF2B5EF4-FFF2-40B4-BE49-F238E27FC236}">
                          <a16:creationId xmlns:a16="http://schemas.microsoft.com/office/drawing/2014/main" id="{96E29F1A-F57C-E8C9-8631-3FCFCB3B467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0284489" y="4756150"/>
                      <a:ext cx="171450" cy="27305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lIns="0" rIns="0" rtlCol="0" anchor="ctr"/>
                    <a:lstStyle/>
                    <a:p>
                      <a:pPr algn="ctr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B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35" name="직사각형 67">
                      <a:extLst>
                        <a:ext uri="{FF2B5EF4-FFF2-40B4-BE49-F238E27FC236}">
                          <a16:creationId xmlns:a16="http://schemas.microsoft.com/office/drawing/2014/main" id="{03AE4D10-9D60-C566-C188-1243151F6C4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0528200" y="4756150"/>
                      <a:ext cx="171450" cy="27305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lIns="0" rIns="0" rtlCol="0" anchor="ctr"/>
                    <a:lstStyle/>
                    <a:p>
                      <a:pPr algn="ctr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C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36" name="직사각형 68">
                      <a:extLst>
                        <a:ext uri="{FF2B5EF4-FFF2-40B4-BE49-F238E27FC236}">
                          <a16:creationId xmlns:a16="http://schemas.microsoft.com/office/drawing/2014/main" id="{0EB1DB86-CDA0-305B-EDB2-FB963A94BD8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0771911" y="4756150"/>
                      <a:ext cx="171450" cy="27305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lIns="0" rIns="0" rtlCol="0" anchor="ctr"/>
                    <a:lstStyle/>
                    <a:p>
                      <a:pPr algn="ctr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D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37" name="직사각형 69">
                      <a:extLst>
                        <a:ext uri="{FF2B5EF4-FFF2-40B4-BE49-F238E27FC236}">
                          <a16:creationId xmlns:a16="http://schemas.microsoft.com/office/drawing/2014/main" id="{4974929D-6B2F-7C9B-3ED2-693C747F492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0958472" y="4756150"/>
                      <a:ext cx="171450" cy="27305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lIns="0" rIns="0" rtlCol="0" anchor="ctr"/>
                    <a:lstStyle/>
                    <a:p>
                      <a:pPr algn="ctr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A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38" name="직사각형 70">
                      <a:extLst>
                        <a:ext uri="{FF2B5EF4-FFF2-40B4-BE49-F238E27FC236}">
                          <a16:creationId xmlns:a16="http://schemas.microsoft.com/office/drawing/2014/main" id="{31839CEE-9279-5408-A96B-DB3A9C669B5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1125983" y="4756150"/>
                      <a:ext cx="171450" cy="27305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lIns="0" rIns="0" rtlCol="0" anchor="ctr"/>
                    <a:lstStyle/>
                    <a:p>
                      <a:pPr algn="ctr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B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39" name="직사각형 71">
                      <a:extLst>
                        <a:ext uri="{FF2B5EF4-FFF2-40B4-BE49-F238E27FC236}">
                          <a16:creationId xmlns:a16="http://schemas.microsoft.com/office/drawing/2014/main" id="{98814180-F4C8-42B2-2B40-E3E26CFD693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1280640" y="4756150"/>
                      <a:ext cx="171450" cy="27305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lIns="0" rIns="0" rtlCol="0" anchor="ctr"/>
                    <a:lstStyle/>
                    <a:p>
                      <a:pPr algn="ctr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C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40" name="직사각형 72">
                      <a:extLst>
                        <a:ext uri="{FF2B5EF4-FFF2-40B4-BE49-F238E27FC236}">
                          <a16:creationId xmlns:a16="http://schemas.microsoft.com/office/drawing/2014/main" id="{34E50D51-0B61-18FF-DD53-A31E8A641CE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1441944" y="4756150"/>
                      <a:ext cx="171450" cy="27305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lIns="0" rIns="0" rtlCol="0" anchor="ctr"/>
                    <a:lstStyle/>
                    <a:p>
                      <a:pPr algn="ctr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D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pic>
                <p:nvPicPr>
                  <p:cNvPr id="512" name="그림 5">
                    <a:extLst>
                      <a:ext uri="{FF2B5EF4-FFF2-40B4-BE49-F238E27FC236}">
                        <a16:creationId xmlns:a16="http://schemas.microsoft.com/office/drawing/2014/main" id="{7BCF4FC4-A879-DD66-8966-834F207EA1B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0000" t="4338" r="4642" b="3865"/>
                  <a:stretch/>
                </p:blipFill>
                <p:spPr>
                  <a:xfrm>
                    <a:off x="581071" y="5289017"/>
                    <a:ext cx="5529943" cy="2686050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503" name="그룹 14">
                  <a:extLst>
                    <a:ext uri="{FF2B5EF4-FFF2-40B4-BE49-F238E27FC236}">
                      <a16:creationId xmlns:a16="http://schemas.microsoft.com/office/drawing/2014/main" id="{0809C694-A631-181A-E2D8-C27900CBB98E}"/>
                    </a:ext>
                  </a:extLst>
                </p:cNvPr>
                <p:cNvGrpSpPr/>
                <p:nvPr/>
              </p:nvGrpSpPr>
              <p:grpSpPr>
                <a:xfrm>
                  <a:off x="247650" y="5329657"/>
                  <a:ext cx="336550" cy="2604770"/>
                  <a:chOff x="234950" y="2114550"/>
                  <a:chExt cx="336550" cy="2604770"/>
                </a:xfrm>
              </p:grpSpPr>
              <p:sp>
                <p:nvSpPr>
                  <p:cNvPr id="504" name="직사각형 7">
                    <a:extLst>
                      <a:ext uri="{FF2B5EF4-FFF2-40B4-BE49-F238E27FC236}">
                        <a16:creationId xmlns:a16="http://schemas.microsoft.com/office/drawing/2014/main" id="{22C6AF01-F9CF-450B-6866-B1BDB8FB5E67}"/>
                      </a:ext>
                    </a:extLst>
                  </p:cNvPr>
                  <p:cNvSpPr/>
                  <p:nvPr/>
                </p:nvSpPr>
                <p:spPr>
                  <a:xfrm>
                    <a:off x="234950" y="2114550"/>
                    <a:ext cx="336550" cy="27305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lIns="0" rIns="0" rtlCol="0" anchor="ctr"/>
                  <a:lstStyle/>
                  <a:p>
                    <a:pPr algn="ctr"/>
                    <a:r>
                      <a:rPr lang="en-US" altLang="ko-KR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vb1</a:t>
                    </a:r>
                    <a:endParaRPr lang="ko-KR" altLang="en-US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05" name="직사각형 8">
                    <a:extLst>
                      <a:ext uri="{FF2B5EF4-FFF2-40B4-BE49-F238E27FC236}">
                        <a16:creationId xmlns:a16="http://schemas.microsoft.com/office/drawing/2014/main" id="{BDF99FA6-6A47-03E1-47E1-B4D8A19C3D4D}"/>
                      </a:ext>
                    </a:extLst>
                  </p:cNvPr>
                  <p:cNvSpPr/>
                  <p:nvPr/>
                </p:nvSpPr>
                <p:spPr>
                  <a:xfrm>
                    <a:off x="234950" y="2399665"/>
                    <a:ext cx="336550" cy="27305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lIns="0" rIns="0" rtlCol="0" anchor="ctr"/>
                  <a:lstStyle/>
                  <a:p>
                    <a:pPr algn="ctr"/>
                    <a:r>
                      <a:rPr lang="en-US" altLang="ko-KR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vb2</a:t>
                    </a:r>
                    <a:endParaRPr lang="ko-KR" altLang="en-US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06" name="직사각형 9">
                    <a:extLst>
                      <a:ext uri="{FF2B5EF4-FFF2-40B4-BE49-F238E27FC236}">
                        <a16:creationId xmlns:a16="http://schemas.microsoft.com/office/drawing/2014/main" id="{06955D9E-CF98-1E84-1DAF-C36D7A5169C9}"/>
                      </a:ext>
                    </a:extLst>
                  </p:cNvPr>
                  <p:cNvSpPr/>
                  <p:nvPr/>
                </p:nvSpPr>
                <p:spPr>
                  <a:xfrm>
                    <a:off x="234950" y="2812415"/>
                    <a:ext cx="336550" cy="27305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lIns="0" rIns="0" rtlCol="0" anchor="ctr"/>
                  <a:lstStyle/>
                  <a:p>
                    <a:pPr algn="ctr"/>
                    <a:r>
                      <a:rPr lang="en-US" altLang="ko-KR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vb3</a:t>
                    </a:r>
                    <a:endParaRPr lang="ko-KR" altLang="en-US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07" name="직사각형 10">
                    <a:extLst>
                      <a:ext uri="{FF2B5EF4-FFF2-40B4-BE49-F238E27FC236}">
                        <a16:creationId xmlns:a16="http://schemas.microsoft.com/office/drawing/2014/main" id="{E6182AD3-9273-7A14-FEAF-1A680BDFD5DB}"/>
                      </a:ext>
                    </a:extLst>
                  </p:cNvPr>
                  <p:cNvSpPr/>
                  <p:nvPr/>
                </p:nvSpPr>
                <p:spPr>
                  <a:xfrm>
                    <a:off x="234950" y="3243580"/>
                    <a:ext cx="336550" cy="27305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lIns="0" rIns="0" rtlCol="0" anchor="ctr"/>
                  <a:lstStyle/>
                  <a:p>
                    <a:pPr algn="ctr"/>
                    <a:r>
                      <a:rPr lang="en-US" altLang="ko-KR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vb4</a:t>
                    </a:r>
                    <a:endParaRPr lang="ko-KR" altLang="en-US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08" name="직사각형 11">
                    <a:extLst>
                      <a:ext uri="{FF2B5EF4-FFF2-40B4-BE49-F238E27FC236}">
                        <a16:creationId xmlns:a16="http://schemas.microsoft.com/office/drawing/2014/main" id="{DF398502-80CF-0B5C-BB95-29EF6C74D196}"/>
                      </a:ext>
                    </a:extLst>
                  </p:cNvPr>
                  <p:cNvSpPr/>
                  <p:nvPr/>
                </p:nvSpPr>
                <p:spPr>
                  <a:xfrm>
                    <a:off x="234950" y="3636645"/>
                    <a:ext cx="336550" cy="27305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lIns="0" rIns="0" rtlCol="0" anchor="ctr"/>
                  <a:lstStyle/>
                  <a:p>
                    <a:pPr algn="ctr"/>
                    <a:r>
                      <a:rPr lang="en-US" altLang="ko-KR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vb5</a:t>
                    </a:r>
                    <a:endParaRPr lang="ko-KR" altLang="en-US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09" name="직사각형 12">
                    <a:extLst>
                      <a:ext uri="{FF2B5EF4-FFF2-40B4-BE49-F238E27FC236}">
                        <a16:creationId xmlns:a16="http://schemas.microsoft.com/office/drawing/2014/main" id="{EF98324D-91CC-7DC1-C5DA-EA2C9AAE264F}"/>
                      </a:ext>
                    </a:extLst>
                  </p:cNvPr>
                  <p:cNvSpPr/>
                  <p:nvPr/>
                </p:nvSpPr>
                <p:spPr>
                  <a:xfrm>
                    <a:off x="234950" y="4046855"/>
                    <a:ext cx="336550" cy="27305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lIns="0" rIns="0" rtlCol="0" anchor="ctr"/>
                  <a:lstStyle/>
                  <a:p>
                    <a:pPr algn="ctr"/>
                    <a:r>
                      <a:rPr lang="en-US" altLang="ko-KR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vb6</a:t>
                    </a:r>
                    <a:endParaRPr lang="ko-KR" altLang="en-US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10" name="직사각형 13">
                    <a:extLst>
                      <a:ext uri="{FF2B5EF4-FFF2-40B4-BE49-F238E27FC236}">
                        <a16:creationId xmlns:a16="http://schemas.microsoft.com/office/drawing/2014/main" id="{1CF22C1E-AD9E-5C9A-A14D-032E04C002BC}"/>
                      </a:ext>
                    </a:extLst>
                  </p:cNvPr>
                  <p:cNvSpPr/>
                  <p:nvPr/>
                </p:nvSpPr>
                <p:spPr>
                  <a:xfrm>
                    <a:off x="234950" y="4446270"/>
                    <a:ext cx="336550" cy="27305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lIns="0" rIns="0" rtlCol="0" anchor="ctr"/>
                  <a:lstStyle/>
                  <a:p>
                    <a:pPr algn="ctr"/>
                    <a:r>
                      <a:rPr lang="en-US" altLang="ko-KR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vb7</a:t>
                    </a:r>
                    <a:endParaRPr lang="ko-KR" altLang="en-US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sp>
          <p:nvSpPr>
            <p:cNvPr id="498" name="TextBox 497">
              <a:extLst>
                <a:ext uri="{FF2B5EF4-FFF2-40B4-BE49-F238E27FC236}">
                  <a16:creationId xmlns:a16="http://schemas.microsoft.com/office/drawing/2014/main" id="{362003D2-E3C3-C5C1-89B6-2ACCAD6737FB}"/>
                </a:ext>
              </a:extLst>
            </p:cNvPr>
            <p:cNvSpPr txBox="1"/>
            <p:nvPr/>
          </p:nvSpPr>
          <p:spPr>
            <a:xfrm>
              <a:off x="2083981" y="8549674"/>
              <a:ext cx="433077" cy="3566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499" name="TextBox 498">
              <a:extLst>
                <a:ext uri="{FF2B5EF4-FFF2-40B4-BE49-F238E27FC236}">
                  <a16:creationId xmlns:a16="http://schemas.microsoft.com/office/drawing/2014/main" id="{F6BD47CD-1E1F-DCCF-8F32-30A258025AB3}"/>
                </a:ext>
              </a:extLst>
            </p:cNvPr>
            <p:cNvSpPr txBox="1"/>
            <p:nvPr/>
          </p:nvSpPr>
          <p:spPr>
            <a:xfrm>
              <a:off x="2083981" y="14706049"/>
              <a:ext cx="433077" cy="3566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9449359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</TotalTime>
  <Words>72</Words>
  <Application>Microsoft Office PowerPoint</Application>
  <PresentationFormat>사용자 지정</PresentationFormat>
  <Paragraphs>7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테마</vt:lpstr>
      <vt:lpstr>PowerPoint 프레젠테이션</vt:lpstr>
    </vt:vector>
  </TitlesOfParts>
  <Company>University of Florid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an, Hyeondae</dc:creator>
  <cp:lastModifiedBy>Han, Hyeondae</cp:lastModifiedBy>
  <cp:revision>6</cp:revision>
  <dcterms:created xsi:type="dcterms:W3CDTF">2024-03-17T20:50:21Z</dcterms:created>
  <dcterms:modified xsi:type="dcterms:W3CDTF">2024-08-09T02:38:12Z</dcterms:modified>
</cp:coreProperties>
</file>